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4"/>
  </p:sldMasterIdLst>
  <p:notesMasterIdLst>
    <p:notesMasterId r:id="rId6"/>
  </p:notesMasterIdLst>
  <p:sldIdLst>
    <p:sldId id="256" r:id="rId5"/>
  </p:sldIdLst>
  <p:sldSz cx="9601200" cy="12801600" type="A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8EDA126-FCF5-AB46-8B18-F1C54E2D86A4}" v="4" dt="2025-10-17T14:22:33.54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58"/>
  </p:normalViewPr>
  <p:slideViewPr>
    <p:cSldViewPr snapToGrid="0">
      <p:cViewPr>
        <p:scale>
          <a:sx n="80" d="100"/>
          <a:sy n="80" d="100"/>
        </p:scale>
        <p:origin x="2896" y="-3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hristian Harding" userId="8cfc3c92-af81-4480-bc90-62f867d20560" providerId="ADAL" clId="{B24B8204-1AB2-5522-BBA9-60E3856FBE99}"/>
    <pc:docChg chg="custSel modSld">
      <pc:chgData name="Christian Harding" userId="8cfc3c92-af81-4480-bc90-62f867d20560" providerId="ADAL" clId="{B24B8204-1AB2-5522-BBA9-60E3856FBE99}" dt="2025-10-17T14:29:28.095" v="1033" actId="1076"/>
      <pc:docMkLst>
        <pc:docMk/>
      </pc:docMkLst>
      <pc:sldChg chg="addSp delSp modSp mod">
        <pc:chgData name="Christian Harding" userId="8cfc3c92-af81-4480-bc90-62f867d20560" providerId="ADAL" clId="{B24B8204-1AB2-5522-BBA9-60E3856FBE99}" dt="2025-10-17T14:29:28.095" v="1033" actId="1076"/>
        <pc:sldMkLst>
          <pc:docMk/>
          <pc:sldMk cId="2393109535" sldId="256"/>
        </pc:sldMkLst>
        <pc:spChg chg="add del mod">
          <ac:chgData name="Christian Harding" userId="8cfc3c92-af81-4480-bc90-62f867d20560" providerId="ADAL" clId="{B24B8204-1AB2-5522-BBA9-60E3856FBE99}" dt="2025-10-17T14:21:24.651" v="13"/>
          <ac:spMkLst>
            <pc:docMk/>
            <pc:sldMk cId="2393109535" sldId="256"/>
            <ac:spMk id="2" creationId="{3200B4FE-6D04-FAE0-05C6-DD6E26E2D427}"/>
          </ac:spMkLst>
        </pc:spChg>
        <pc:spChg chg="add mod">
          <ac:chgData name="Christian Harding" userId="8cfc3c92-af81-4480-bc90-62f867d20560" providerId="ADAL" clId="{B24B8204-1AB2-5522-BBA9-60E3856FBE99}" dt="2025-10-17T14:29:28.095" v="1033" actId="1076"/>
          <ac:spMkLst>
            <pc:docMk/>
            <pc:sldMk cId="2393109535" sldId="256"/>
            <ac:spMk id="2" creationId="{529F904E-CA49-D89D-ECC0-D34D44CCCA9B}"/>
          </ac:spMkLst>
        </pc:spChg>
        <pc:spChg chg="add del mod">
          <ac:chgData name="Christian Harding" userId="8cfc3c92-af81-4480-bc90-62f867d20560" providerId="ADAL" clId="{B24B8204-1AB2-5522-BBA9-60E3856FBE99}" dt="2025-10-17T14:21:24.866" v="15"/>
          <ac:spMkLst>
            <pc:docMk/>
            <pc:sldMk cId="2393109535" sldId="256"/>
            <ac:spMk id="3" creationId="{A11A727A-BF10-CC5A-A3DD-9EC989A806D1}"/>
          </ac:spMkLst>
        </pc:spChg>
        <pc:spChg chg="add del mod">
          <ac:chgData name="Christian Harding" userId="8cfc3c92-af81-4480-bc90-62f867d20560" providerId="ADAL" clId="{B24B8204-1AB2-5522-BBA9-60E3856FBE99}" dt="2025-10-17T14:22:33.224" v="20" actId="478"/>
          <ac:spMkLst>
            <pc:docMk/>
            <pc:sldMk cId="2393109535" sldId="256"/>
            <ac:spMk id="4" creationId="{8D79CD85-E36A-2E71-D572-175071BBBA3F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7B86AF1-D51C-0C48-87E2-3A5DBA0DF32E}" type="datetimeFigureOut">
              <a:rPr lang="en-US" smtClean="0"/>
              <a:t>10/17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B848E51-7E74-DA47-A271-C7F6DAE0D3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07273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12F57-3781-8D4E-B83D-BFC569796919}" type="datetimeFigureOut">
              <a:rPr lang="en-US" smtClean="0"/>
              <a:t>10/1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0CFA4-E11A-C849-80F3-79677EB55E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27605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12F57-3781-8D4E-B83D-BFC569796919}" type="datetimeFigureOut">
              <a:rPr lang="en-US" smtClean="0"/>
              <a:t>10/1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0CFA4-E11A-C849-80F3-79677EB55E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6473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12F57-3781-8D4E-B83D-BFC569796919}" type="datetimeFigureOut">
              <a:rPr lang="en-US" smtClean="0"/>
              <a:t>10/1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0CFA4-E11A-C849-80F3-79677EB55E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57464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12F57-3781-8D4E-B83D-BFC569796919}" type="datetimeFigureOut">
              <a:rPr lang="en-US" smtClean="0"/>
              <a:t>10/1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0CFA4-E11A-C849-80F3-79677EB55E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60073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>
                    <a:tint val="82000"/>
                  </a:schemeClr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82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82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82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82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82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82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82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12F57-3781-8D4E-B83D-BFC569796919}" type="datetimeFigureOut">
              <a:rPr lang="en-US" smtClean="0"/>
              <a:t>10/1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0CFA4-E11A-C849-80F3-79677EB55E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62026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12F57-3781-8D4E-B83D-BFC569796919}" type="datetimeFigureOut">
              <a:rPr lang="en-US" smtClean="0"/>
              <a:t>10/17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0CFA4-E11A-C849-80F3-79677EB55E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27708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12F57-3781-8D4E-B83D-BFC569796919}" type="datetimeFigureOut">
              <a:rPr lang="en-US" smtClean="0"/>
              <a:t>10/17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0CFA4-E11A-C849-80F3-79677EB55E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97940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12F57-3781-8D4E-B83D-BFC569796919}" type="datetimeFigureOut">
              <a:rPr lang="en-US" smtClean="0"/>
              <a:t>10/17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0CFA4-E11A-C849-80F3-79677EB55E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55611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12F57-3781-8D4E-B83D-BFC569796919}" type="datetimeFigureOut">
              <a:rPr lang="en-US" smtClean="0"/>
              <a:t>10/17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0CFA4-E11A-C849-80F3-79677EB55E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65053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12F57-3781-8D4E-B83D-BFC569796919}" type="datetimeFigureOut">
              <a:rPr lang="en-US" smtClean="0"/>
              <a:t>10/17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0CFA4-E11A-C849-80F3-79677EB55E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34645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12F57-3781-8D4E-B83D-BFC569796919}" type="datetimeFigureOut">
              <a:rPr lang="en-US" smtClean="0"/>
              <a:t>10/17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0CFA4-E11A-C849-80F3-79677EB55E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35845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F812F57-3781-8D4E-B83D-BFC569796919}" type="datetimeFigureOut">
              <a:rPr lang="en-US" smtClean="0"/>
              <a:t>10/1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FD0CFA4-E11A-C849-80F3-79677EB55E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25954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red and green light&#10;&#10;AI-generated content may be incorrect.">
            <a:extLst>
              <a:ext uri="{FF2B5EF4-FFF2-40B4-BE49-F238E27FC236}">
                <a16:creationId xmlns:a16="http://schemas.microsoft.com/office/drawing/2014/main" id="{9D124A52-DAA0-00C5-9C1F-4FD2F2F143C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55283" y="3588362"/>
            <a:ext cx="4648334" cy="281243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1E6EBF8A-2D40-F83A-388D-1A6DAE28DA13}"/>
              </a:ext>
            </a:extLst>
          </p:cNvPr>
          <p:cNvSpPr txBox="1"/>
          <p:nvPr/>
        </p:nvSpPr>
        <p:spPr>
          <a:xfrm>
            <a:off x="362746" y="3991062"/>
            <a:ext cx="7104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150 -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CF5E07F-3922-BA1D-D1FF-63B40945DE6B}"/>
              </a:ext>
            </a:extLst>
          </p:cNvPr>
          <p:cNvSpPr txBox="1"/>
          <p:nvPr/>
        </p:nvSpPr>
        <p:spPr>
          <a:xfrm>
            <a:off x="362745" y="4674957"/>
            <a:ext cx="7104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100 -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962DD2E-93D7-0137-F544-D0B931A21E01}"/>
              </a:ext>
            </a:extLst>
          </p:cNvPr>
          <p:cNvSpPr txBox="1"/>
          <p:nvPr/>
        </p:nvSpPr>
        <p:spPr>
          <a:xfrm>
            <a:off x="477044" y="5295987"/>
            <a:ext cx="5822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75 -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50A7FDB-0FA8-3349-6E1B-EEB8144DA303}"/>
              </a:ext>
            </a:extLst>
          </p:cNvPr>
          <p:cNvSpPr txBox="1"/>
          <p:nvPr/>
        </p:nvSpPr>
        <p:spPr>
          <a:xfrm>
            <a:off x="360938" y="3693004"/>
            <a:ext cx="7104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250 -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FABF7E4-EAB1-C73F-08AC-FBA3076139CC}"/>
              </a:ext>
            </a:extLst>
          </p:cNvPr>
          <p:cNvSpPr txBox="1"/>
          <p:nvPr/>
        </p:nvSpPr>
        <p:spPr>
          <a:xfrm>
            <a:off x="350723" y="3288035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u="sng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BD159621-FDBD-2E76-803E-4B207E1C43EB}"/>
              </a:ext>
            </a:extLst>
          </p:cNvPr>
          <p:cNvCxnSpPr>
            <a:cxnSpLocks/>
          </p:cNvCxnSpPr>
          <p:nvPr/>
        </p:nvCxnSpPr>
        <p:spPr>
          <a:xfrm flipH="1">
            <a:off x="5645367" y="4212366"/>
            <a:ext cx="287601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B12DD44E-EC0D-8F82-DBC5-065697335094}"/>
              </a:ext>
            </a:extLst>
          </p:cNvPr>
          <p:cNvCxnSpPr>
            <a:cxnSpLocks/>
          </p:cNvCxnSpPr>
          <p:nvPr/>
        </p:nvCxnSpPr>
        <p:spPr>
          <a:xfrm flipH="1">
            <a:off x="5639246" y="5249186"/>
            <a:ext cx="287601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CD10B7E2-299A-0E76-4F34-997DC9AD9A7B}"/>
              </a:ext>
            </a:extLst>
          </p:cNvPr>
          <p:cNvSpPr txBox="1"/>
          <p:nvPr/>
        </p:nvSpPr>
        <p:spPr>
          <a:xfrm>
            <a:off x="5849072" y="5064520"/>
            <a:ext cx="7574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EPA6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8735D66-563C-86B6-1202-362CF9C9EC16}"/>
              </a:ext>
            </a:extLst>
          </p:cNvPr>
          <p:cNvSpPr txBox="1"/>
          <p:nvPr/>
        </p:nvSpPr>
        <p:spPr>
          <a:xfrm>
            <a:off x="5849071" y="4027700"/>
            <a:ext cx="29851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RNA polymerase β subunit 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4D8C0B8-0DF0-DFF5-5A75-7A48551C2FCE}"/>
              </a:ext>
            </a:extLst>
          </p:cNvPr>
          <p:cNvSpPr txBox="1"/>
          <p:nvPr/>
        </p:nvSpPr>
        <p:spPr>
          <a:xfrm rot="16200000">
            <a:off x="1319014" y="3169892"/>
            <a:ext cx="7120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lone 1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1FCA314-8E34-0807-370F-0FFD63D5C510}"/>
              </a:ext>
            </a:extLst>
          </p:cNvPr>
          <p:cNvSpPr txBox="1"/>
          <p:nvPr/>
        </p:nvSpPr>
        <p:spPr>
          <a:xfrm rot="16200000">
            <a:off x="1636459" y="3169892"/>
            <a:ext cx="7120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lone 2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5E7F0AA-5E64-E4F3-E3D3-9944D3709F31}"/>
              </a:ext>
            </a:extLst>
          </p:cNvPr>
          <p:cNvSpPr txBox="1"/>
          <p:nvPr/>
        </p:nvSpPr>
        <p:spPr>
          <a:xfrm rot="16200000">
            <a:off x="1953904" y="3169891"/>
            <a:ext cx="7120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lone 1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71A9CFD-DD18-9CA0-4554-78E8C4F1C742}"/>
              </a:ext>
            </a:extLst>
          </p:cNvPr>
          <p:cNvSpPr txBox="1"/>
          <p:nvPr/>
        </p:nvSpPr>
        <p:spPr>
          <a:xfrm rot="16200000">
            <a:off x="2271349" y="3169891"/>
            <a:ext cx="7120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lone 2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00C3BFE-4582-12A2-58BE-F678B0787249}"/>
              </a:ext>
            </a:extLst>
          </p:cNvPr>
          <p:cNvSpPr txBox="1"/>
          <p:nvPr/>
        </p:nvSpPr>
        <p:spPr>
          <a:xfrm rot="16200000">
            <a:off x="2588794" y="3169892"/>
            <a:ext cx="7120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lone 1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8B78F31-E83C-27A6-1F21-6695A55B0C7B}"/>
              </a:ext>
            </a:extLst>
          </p:cNvPr>
          <p:cNvSpPr txBox="1"/>
          <p:nvPr/>
        </p:nvSpPr>
        <p:spPr>
          <a:xfrm rot="16200000">
            <a:off x="2906239" y="3169892"/>
            <a:ext cx="7120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lone 2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25F698C-86EB-742F-68E7-FC3C2FA050C3}"/>
              </a:ext>
            </a:extLst>
          </p:cNvPr>
          <p:cNvSpPr txBox="1"/>
          <p:nvPr/>
        </p:nvSpPr>
        <p:spPr>
          <a:xfrm rot="16200000">
            <a:off x="3223684" y="3169891"/>
            <a:ext cx="7120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lone 1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063C227A-3AD0-157D-94CC-A591D5AD9157}"/>
              </a:ext>
            </a:extLst>
          </p:cNvPr>
          <p:cNvSpPr txBox="1"/>
          <p:nvPr/>
        </p:nvSpPr>
        <p:spPr>
          <a:xfrm rot="16200000">
            <a:off x="3541129" y="3169891"/>
            <a:ext cx="7120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lone 2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E631A1EE-4271-AAAE-8948-E0217A4512DB}"/>
              </a:ext>
            </a:extLst>
          </p:cNvPr>
          <p:cNvSpPr txBox="1"/>
          <p:nvPr/>
        </p:nvSpPr>
        <p:spPr>
          <a:xfrm rot="16200000">
            <a:off x="3858574" y="3169891"/>
            <a:ext cx="7120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lone 1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38EAB2B-298E-1A0A-9AE3-44BC4F23FFF6}"/>
              </a:ext>
            </a:extLst>
          </p:cNvPr>
          <p:cNvSpPr txBox="1"/>
          <p:nvPr/>
        </p:nvSpPr>
        <p:spPr>
          <a:xfrm rot="16200000">
            <a:off x="4176019" y="3169891"/>
            <a:ext cx="7120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lone 2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4EE6073A-4A36-374F-EC2A-E1DA498CB607}"/>
              </a:ext>
            </a:extLst>
          </p:cNvPr>
          <p:cNvSpPr txBox="1"/>
          <p:nvPr/>
        </p:nvSpPr>
        <p:spPr>
          <a:xfrm rot="16200000">
            <a:off x="4493464" y="3169890"/>
            <a:ext cx="7120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lone 1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03E3CCA-0574-65D8-4642-44C6A701A07B}"/>
              </a:ext>
            </a:extLst>
          </p:cNvPr>
          <p:cNvSpPr txBox="1"/>
          <p:nvPr/>
        </p:nvSpPr>
        <p:spPr>
          <a:xfrm rot="16200000">
            <a:off x="4810908" y="3169890"/>
            <a:ext cx="7120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lone 2</a:t>
            </a:r>
          </a:p>
        </p:txBody>
      </p:sp>
      <p:sp>
        <p:nvSpPr>
          <p:cNvPr id="31" name="Left Brace 30">
            <a:extLst>
              <a:ext uri="{FF2B5EF4-FFF2-40B4-BE49-F238E27FC236}">
                <a16:creationId xmlns:a16="http://schemas.microsoft.com/office/drawing/2014/main" id="{9B9F531A-2B1D-AB83-DFAA-53606C3549EC}"/>
              </a:ext>
            </a:extLst>
          </p:cNvPr>
          <p:cNvSpPr/>
          <p:nvPr/>
        </p:nvSpPr>
        <p:spPr>
          <a:xfrm rot="5400000">
            <a:off x="1752256" y="2592713"/>
            <a:ext cx="143935" cy="575365"/>
          </a:xfrm>
          <a:prstGeom prst="leftBrac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Left Brace 32">
            <a:extLst>
              <a:ext uri="{FF2B5EF4-FFF2-40B4-BE49-F238E27FC236}">
                <a16:creationId xmlns:a16="http://schemas.microsoft.com/office/drawing/2014/main" id="{B67BFD1F-C98F-009A-B105-819DD1D9AA99}"/>
              </a:ext>
            </a:extLst>
          </p:cNvPr>
          <p:cNvSpPr/>
          <p:nvPr/>
        </p:nvSpPr>
        <p:spPr>
          <a:xfrm rot="5400000">
            <a:off x="2388752" y="2592713"/>
            <a:ext cx="143935" cy="575365"/>
          </a:xfrm>
          <a:prstGeom prst="leftBrac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Left Brace 33">
            <a:extLst>
              <a:ext uri="{FF2B5EF4-FFF2-40B4-BE49-F238E27FC236}">
                <a16:creationId xmlns:a16="http://schemas.microsoft.com/office/drawing/2014/main" id="{FE1A519A-E599-CAC1-E8DD-545035D77E59}"/>
              </a:ext>
            </a:extLst>
          </p:cNvPr>
          <p:cNvSpPr/>
          <p:nvPr/>
        </p:nvSpPr>
        <p:spPr>
          <a:xfrm rot="5400000">
            <a:off x="3066674" y="2592713"/>
            <a:ext cx="143935" cy="575365"/>
          </a:xfrm>
          <a:prstGeom prst="leftBrac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Left Brace 34">
            <a:extLst>
              <a:ext uri="{FF2B5EF4-FFF2-40B4-BE49-F238E27FC236}">
                <a16:creationId xmlns:a16="http://schemas.microsoft.com/office/drawing/2014/main" id="{63242DE5-8788-695B-9DE4-BCE04700B9A9}"/>
              </a:ext>
            </a:extLst>
          </p:cNvPr>
          <p:cNvSpPr/>
          <p:nvPr/>
        </p:nvSpPr>
        <p:spPr>
          <a:xfrm rot="5400000">
            <a:off x="3703170" y="2592713"/>
            <a:ext cx="143935" cy="575365"/>
          </a:xfrm>
          <a:prstGeom prst="leftBrac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Left Brace 37">
            <a:extLst>
              <a:ext uri="{FF2B5EF4-FFF2-40B4-BE49-F238E27FC236}">
                <a16:creationId xmlns:a16="http://schemas.microsoft.com/office/drawing/2014/main" id="{5B41D1D1-CB43-B60C-D8D2-0DE0A032EB8E}"/>
              </a:ext>
            </a:extLst>
          </p:cNvPr>
          <p:cNvSpPr/>
          <p:nvPr/>
        </p:nvSpPr>
        <p:spPr>
          <a:xfrm rot="5400000">
            <a:off x="4347183" y="2592712"/>
            <a:ext cx="143935" cy="575365"/>
          </a:xfrm>
          <a:prstGeom prst="leftBrac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Left Brace 38">
            <a:extLst>
              <a:ext uri="{FF2B5EF4-FFF2-40B4-BE49-F238E27FC236}">
                <a16:creationId xmlns:a16="http://schemas.microsoft.com/office/drawing/2014/main" id="{23DF27CE-A47D-6F43-256B-537582347D8A}"/>
              </a:ext>
            </a:extLst>
          </p:cNvPr>
          <p:cNvSpPr/>
          <p:nvPr/>
        </p:nvSpPr>
        <p:spPr>
          <a:xfrm rot="5400000">
            <a:off x="4983679" y="2592712"/>
            <a:ext cx="143935" cy="575365"/>
          </a:xfrm>
          <a:prstGeom prst="leftBrac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5F134B48-6D16-39DD-996F-D220BE3D9770}"/>
              </a:ext>
            </a:extLst>
          </p:cNvPr>
          <p:cNvSpPr txBox="1"/>
          <p:nvPr/>
        </p:nvSpPr>
        <p:spPr>
          <a:xfrm rot="18900000">
            <a:off x="1540868" y="2231058"/>
            <a:ext cx="12971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EPA6(6XHis)-</a:t>
            </a:r>
            <a:r>
              <a:rPr lang="en-US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PglS</a:t>
            </a:r>
            <a:r>
              <a:rPr lang="en-US" sz="900" b="1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9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789E3D11-F106-F624-D3BE-7E3316657832}"/>
              </a:ext>
            </a:extLst>
          </p:cNvPr>
          <p:cNvSpPr txBox="1"/>
          <p:nvPr/>
        </p:nvSpPr>
        <p:spPr>
          <a:xfrm rot="18900000">
            <a:off x="2805035" y="2110572"/>
            <a:ext cx="16818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EPA6(6XHis)-PglS</a:t>
            </a:r>
            <a:r>
              <a:rPr lang="en-US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T268F_K312E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2675A596-74C9-5BCB-35B3-C1CD53A23216}"/>
              </a:ext>
            </a:extLst>
          </p:cNvPr>
          <p:cNvSpPr txBox="1"/>
          <p:nvPr/>
        </p:nvSpPr>
        <p:spPr>
          <a:xfrm rot="18900000">
            <a:off x="4025541" y="1993689"/>
            <a:ext cx="201048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EPA6(6XHis)-PglS</a:t>
            </a:r>
            <a:r>
              <a:rPr lang="en-US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N28W_T268F_K312E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CEBF6802-9911-1E83-4EDA-DDAF28C6F595}"/>
              </a:ext>
            </a:extLst>
          </p:cNvPr>
          <p:cNvSpPr txBox="1"/>
          <p:nvPr/>
        </p:nvSpPr>
        <p:spPr>
          <a:xfrm rot="18900000">
            <a:off x="2103993" y="2110896"/>
            <a:ext cx="168828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EPA6(6XHis)-PglS(FLAG)</a:t>
            </a:r>
            <a:r>
              <a:rPr lang="en-US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FCA41F0B-1303-7487-5577-A7AA9B91C4A3}"/>
              </a:ext>
            </a:extLst>
          </p:cNvPr>
          <p:cNvSpPr txBox="1"/>
          <p:nvPr/>
        </p:nvSpPr>
        <p:spPr>
          <a:xfrm rot="18900000">
            <a:off x="3368160" y="1972394"/>
            <a:ext cx="207300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EPA6(6XHis)-PglS(FLAG)</a:t>
            </a:r>
            <a:r>
              <a:rPr lang="en-US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T268F_K312E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D15D49B9-2138-4D35-2B2E-AF298DD94E91}"/>
              </a:ext>
            </a:extLst>
          </p:cNvPr>
          <p:cNvSpPr txBox="1"/>
          <p:nvPr/>
        </p:nvSpPr>
        <p:spPr>
          <a:xfrm rot="18900000">
            <a:off x="4610420" y="1873527"/>
            <a:ext cx="233108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EPA6(6XHis)-PglS(FLAG)</a:t>
            </a:r>
            <a:r>
              <a:rPr lang="en-US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N28W_T268F_K312E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29F904E-CA49-D89D-ECC0-D34D44CCCA9B}"/>
              </a:ext>
            </a:extLst>
          </p:cNvPr>
          <p:cNvSpPr txBox="1"/>
          <p:nvPr/>
        </p:nvSpPr>
        <p:spPr>
          <a:xfrm>
            <a:off x="898195" y="6745121"/>
            <a:ext cx="7739538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/>
            <a:r>
              <a:rPr lang="en-US" sz="12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5. EPA6 protein expression associated with each PglS variant. 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estern blot analysis on whole cell lysates of VNM13 probing for EPA6-His expression. Each strain simultaneously co-expressed a PglS variant (wildtype, T268F K312E mutant, or N28W T268F K312E mutant) that was either C-terminally FLAG tagged or not. Two clones for each strain were assessed via western blotting for EPA6-His expression after 20 hours of induction. EPA6-His was detected with a monoclonal anti-His antibody and is shown in red. As a loading control, the RNA polymerase β subunit was also probed on the same western blot demonstrating equivalent loading for each cell line. </a:t>
            </a:r>
            <a:r>
              <a:rPr lang="en-US" sz="12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PA6-His expression was observed to relatively the same for all strains tested.</a:t>
            </a:r>
            <a:endParaRPr lang="en-US" sz="1200" kern="100" dirty="0">
              <a:effectLst/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931095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8E8871314C8434FB52206FC0D75AEC5" ma:contentTypeVersion="15" ma:contentTypeDescription="Create a new document." ma:contentTypeScope="" ma:versionID="9669befa45aa3885246f648b2dbc40ad">
  <xsd:schema xmlns:xsd="http://www.w3.org/2001/XMLSchema" xmlns:xs="http://www.w3.org/2001/XMLSchema" xmlns:p="http://schemas.microsoft.com/office/2006/metadata/properties" xmlns:ns2="324db12f-297c-40e3-86f6-4d82186512ff" xmlns:ns3="28e55284-abd9-4569-8d7b-f719476aa490" targetNamespace="http://schemas.microsoft.com/office/2006/metadata/properties" ma:root="true" ma:fieldsID="82e65c3b09da1b7f028bd4253ea4a73e" ns2:_="" ns3:_="">
    <xsd:import namespace="324db12f-297c-40e3-86f6-4d82186512ff"/>
    <xsd:import namespace="28e55284-abd9-4569-8d7b-f719476aa490"/>
    <xsd:element name="properties">
      <xsd:complexType>
        <xsd:sequence>
          <xsd:element name="documentManagement">
            <xsd:complexType>
              <xsd:all>
                <xsd:element ref="ns2:MigrationWizId" minOccurs="0"/>
                <xsd:element ref="ns2:MigrationWizIdPermissions" minOccurs="0"/>
                <xsd:element ref="ns2:MigrationWizIdVersion" minOccurs="0"/>
                <xsd:element ref="ns2:MediaServiceMetadata" minOccurs="0"/>
                <xsd:element ref="ns2:MediaServiceFastMetadata" minOccurs="0"/>
                <xsd:element ref="ns2:MediaServiceSearchProperties" minOccurs="0"/>
                <xsd:element ref="ns2:MediaServiceObjectDetectorVersions" minOccurs="0"/>
                <xsd:element ref="ns2:lcf76f155ced4ddcb4097134ff3c332f" minOccurs="0"/>
                <xsd:element ref="ns3:TaxCatchAll" minOccurs="0"/>
                <xsd:element ref="ns2:MediaServiceDateTaken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24db12f-297c-40e3-86f6-4d82186512ff" elementFormDefault="qualified">
    <xsd:import namespace="http://schemas.microsoft.com/office/2006/documentManagement/types"/>
    <xsd:import namespace="http://schemas.microsoft.com/office/infopath/2007/PartnerControls"/>
    <xsd:element name="MigrationWizId" ma:index="8" nillable="true" ma:displayName="MigrationWizId" ma:internalName="MigrationWizId">
      <xsd:simpleType>
        <xsd:restriction base="dms:Text"/>
      </xsd:simpleType>
    </xsd:element>
    <xsd:element name="MigrationWizIdPermissions" ma:index="9" nillable="true" ma:displayName="MigrationWizIdPermissions" ma:internalName="MigrationWizIdPermissions">
      <xsd:simpleType>
        <xsd:restriction base="dms:Text"/>
      </xsd:simpleType>
    </xsd:element>
    <xsd:element name="MigrationWizIdVersion" ma:index="10" nillable="true" ma:displayName="MigrationWizIdVersion" ma:internalName="MigrationWizIdVersion">
      <xsd:simpleType>
        <xsd:restriction base="dms:Text"/>
      </xsd:simpleType>
    </xsd:element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3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4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lcf76f155ced4ddcb4097134ff3c332f" ma:index="16" nillable="true" ma:taxonomy="true" ma:internalName="lcf76f155ced4ddcb4097134ff3c332f" ma:taxonomyFieldName="MediaServiceImageTags" ma:displayName="Image Tags" ma:readOnly="false" ma:fieldId="{5cf76f15-5ced-4ddc-b409-7134ff3c332f}" ma:taxonomyMulti="true" ma:sspId="d6ac3562-be2b-463b-9688-fb9859eb15c9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DateTaken" ma:index="18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OCR" ma:index="19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20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21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Location" ma:index="22" nillable="true" ma:displayName="Location" ma:indexed="true" ma:internalName="MediaServiceLocatio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8e55284-abd9-4569-8d7b-f719476aa490" elementFormDefault="qualified">
    <xsd:import namespace="http://schemas.microsoft.com/office/2006/documentManagement/types"/>
    <xsd:import namespace="http://schemas.microsoft.com/office/infopath/2007/PartnerControls"/>
    <xsd:element name="TaxCatchAll" ma:index="17" nillable="true" ma:displayName="Taxonomy Catch All Column" ma:hidden="true" ma:list="{652b7d07-4398-489a-9ec2-57654188717d}" ma:internalName="TaxCatchAll" ma:showField="CatchAllData" ma:web="28e55284-abd9-4569-8d7b-f719476aa490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MigrationWizIdVersion xmlns="324db12f-297c-40e3-86f6-4d82186512ff" xsi:nil="true"/>
    <lcf76f155ced4ddcb4097134ff3c332f xmlns="324db12f-297c-40e3-86f6-4d82186512ff">
      <Terms xmlns="http://schemas.microsoft.com/office/infopath/2007/PartnerControls"/>
    </lcf76f155ced4ddcb4097134ff3c332f>
    <MigrationWizIdPermissions xmlns="324db12f-297c-40e3-86f6-4d82186512ff" xsi:nil="true"/>
    <MigrationWizId xmlns="324db12f-297c-40e3-86f6-4d82186512ff" xsi:nil="true"/>
    <TaxCatchAll xmlns="28e55284-abd9-4569-8d7b-f719476aa490" xsi:nil="true"/>
  </documentManagement>
</p:properties>
</file>

<file path=customXml/itemProps1.xml><?xml version="1.0" encoding="utf-8"?>
<ds:datastoreItem xmlns:ds="http://schemas.openxmlformats.org/officeDocument/2006/customXml" ds:itemID="{3F74C1E8-4260-42F7-973E-717A3DB6FFEE}"/>
</file>

<file path=customXml/itemProps2.xml><?xml version="1.0" encoding="utf-8"?>
<ds:datastoreItem xmlns:ds="http://schemas.openxmlformats.org/officeDocument/2006/customXml" ds:itemID="{10BEE957-BAEF-49A1-8911-B8D3E568B788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9097CCD5-A9DC-488A-BF39-88CB01387725}">
  <ds:schemaRefs>
    <ds:schemaRef ds:uri="http://schemas.microsoft.com/office/2006/documentManagement/types"/>
    <ds:schemaRef ds:uri="http://schemas.microsoft.com/office/2006/metadata/properties"/>
    <ds:schemaRef ds:uri="324db12f-297c-40e3-86f6-4d82186512ff"/>
    <ds:schemaRef ds:uri="http://www.w3.org/XML/1998/namespace"/>
    <ds:schemaRef ds:uri="http://schemas.microsoft.com/office/infopath/2007/PartnerControls"/>
    <ds:schemaRef ds:uri="http://purl.org/dc/elements/1.1/"/>
    <ds:schemaRef ds:uri="http://schemas.openxmlformats.org/package/2006/metadata/core-properties"/>
    <ds:schemaRef ds:uri="28e55284-abd9-4569-8d7b-f719476aa490"/>
    <ds:schemaRef ds:uri="http://purl.org/dc/dcmitype/"/>
    <ds:schemaRef ds:uri="http://purl.org/dc/terms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5</TotalTime>
  <Words>207</Words>
  <Application>Microsoft Macintosh PowerPoint</Application>
  <PresentationFormat>A3 Paper (297x420 mm)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hristian Harding</dc:creator>
  <cp:lastModifiedBy>Christian Harding</cp:lastModifiedBy>
  <cp:revision>1</cp:revision>
  <dcterms:created xsi:type="dcterms:W3CDTF">2025-10-16T13:51:49Z</dcterms:created>
  <dcterms:modified xsi:type="dcterms:W3CDTF">2025-10-17T14:29:3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8E8871314C8434FB52206FC0D75AEC5</vt:lpwstr>
  </property>
  <property fmtid="{D5CDD505-2E9C-101B-9397-08002B2CF9AE}" pid="3" name="MediaServiceImageTags">
    <vt:lpwstr/>
  </property>
</Properties>
</file>